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100B5-7D4A-41E7-9B20-FDEC7E87BB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6E7D4-2E86-47B7-A616-3843D90DC4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E9A98-9B9A-49D4-A244-2AEC11929A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D2FA8-51BD-403B-A423-2C0EA3F359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48E99-E857-4CF3-932B-BFD0DC31C3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0E11C-4D87-4E8B-AA46-E05F2A1CD5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C7C98C-F530-4B0B-8C90-2032977663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EEF01-0CA2-4941-92CE-97C140779F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965AB-69B6-4B4A-A669-318C529C15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F16B0-E835-4B89-BC81-A185E233F5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1246D-BED5-4649-A8D7-60AE78E16A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94D77-E525-464E-BF6F-507BA69039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2EA6E9-5DB6-484B-9254-27EBAAEE05D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"/>
          <p:cNvGrpSpPr/>
          <p:nvPr/>
        </p:nvGrpSpPr>
        <p:grpSpPr>
          <a:xfrm>
            <a:off x="702000" y="1187280"/>
            <a:ext cx="4598640" cy="6591600"/>
            <a:chOff x="702000" y="1187280"/>
            <a:chExt cx="4598640" cy="6591600"/>
          </a:xfrm>
        </p:grpSpPr>
        <p:pic>
          <p:nvPicPr>
            <p:cNvPr id="42" name="Picture 3" descr=""/>
            <p:cNvPicPr/>
            <p:nvPr/>
          </p:nvPicPr>
          <p:blipFill>
            <a:blip r:embed="rId1">
              <a:grayscl/>
            </a:blip>
            <a:srcRect l="38379" t="44094" r="30079" b="14562"/>
            <a:stretch/>
          </p:blipFill>
          <p:spPr>
            <a:xfrm>
              <a:off x="2204280" y="4897800"/>
              <a:ext cx="2880360" cy="212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5"/>
            <p:cNvSpPr/>
            <p:nvPr/>
          </p:nvSpPr>
          <p:spPr>
            <a:xfrm>
              <a:off x="2420280" y="7380360"/>
              <a:ext cx="2376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6K1 and survival ( glioblastoma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rat et al. J clin.oncol. 200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Picture 4" descr=""/>
            <p:cNvPicPr/>
            <p:nvPr/>
          </p:nvPicPr>
          <p:blipFill>
            <a:blip r:embed="rId2">
              <a:grayscl/>
            </a:blip>
            <a:srcRect l="37865" t="44094" r="25928" b="14562"/>
            <a:stretch/>
          </p:blipFill>
          <p:spPr>
            <a:xfrm>
              <a:off x="2047680" y="1795320"/>
              <a:ext cx="3252960" cy="208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Box 7"/>
            <p:cNvSpPr/>
            <p:nvPr/>
          </p:nvSpPr>
          <p:spPr>
            <a:xfrm>
              <a:off x="2231640" y="4027680"/>
              <a:ext cx="2952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6K1 and survival ( classic medulloblastoma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mery et al. Nature 200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6"/>
            <p:cNvSpPr/>
            <p:nvPr/>
          </p:nvSpPr>
          <p:spPr>
            <a:xfrm>
              <a:off x="702000" y="1187280"/>
              <a:ext cx="140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upplementary Figure 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8"/>
            <p:cNvSpPr/>
            <p:nvPr/>
          </p:nvSpPr>
          <p:spPr>
            <a:xfrm>
              <a:off x="839160" y="4932000"/>
              <a:ext cx="34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9"/>
            <p:cNvSpPr/>
            <p:nvPr/>
          </p:nvSpPr>
          <p:spPr>
            <a:xfrm>
              <a:off x="842760" y="1619280"/>
              <a:ext cx="34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Straight Connector 11"/>
            <p:cNvSpPr/>
            <p:nvPr/>
          </p:nvSpPr>
          <p:spPr>
            <a:xfrm>
              <a:off x="3500640" y="1619280"/>
              <a:ext cx="10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2"/>
            <p:cNvSpPr/>
            <p:nvPr/>
          </p:nvSpPr>
          <p:spPr>
            <a:xfrm>
              <a:off x="3572640" y="133128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 P=0.0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Straight Connector 14"/>
            <p:cNvSpPr/>
            <p:nvPr/>
          </p:nvSpPr>
          <p:spPr>
            <a:xfrm>
              <a:off x="3716640" y="4788000"/>
              <a:ext cx="9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5"/>
            <p:cNvSpPr/>
            <p:nvPr/>
          </p:nvSpPr>
          <p:spPr>
            <a:xfrm>
              <a:off x="3788640" y="457164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1T01:35:52Z</dcterms:created>
  <dc:creator>Sara</dc:creator>
  <dc:description/>
  <dc:language>en-US</dc:language>
  <cp:lastModifiedBy>Sara</cp:lastModifiedBy>
  <dcterms:modified xsi:type="dcterms:W3CDTF">2012-01-02T00:24:55Z</dcterms:modified>
  <cp:revision>2</cp:revision>
  <dc:subject/>
  <dc:title>Slide 1</dc:title>
</cp:coreProperties>
</file>